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5148451236670497E-2"/>
          <c:y val="0.262775173785677"/>
          <c:w val="0.54476648691780605"/>
          <c:h val="0.61627583867739"/>
        </c:manualLayout>
      </c:layout>
      <c:lineChart>
        <c:grouping val="standard"/>
        <c:varyColors val="0"/>
        <c:ser>
          <c:idx val="0"/>
          <c:order val="0"/>
          <c:tx>
            <c:strRef>
              <c:f>'gum operon'!$A$17</c:f>
              <c:strCache>
                <c:ptCount val="1"/>
                <c:pt idx="0">
                  <c:v>gumM (Xoo3168)</c:v>
                </c:pt>
              </c:strCache>
            </c:strRef>
          </c:tx>
          <c:spPr>
            <a:ln w="12700">
              <a:solidFill>
                <a:prstClr val="black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17:$H$17</c:f>
              <c:numCache>
                <c:formatCode>General</c:formatCode>
                <c:ptCount val="7"/>
                <c:pt idx="0">
                  <c:v>1</c:v>
                </c:pt>
                <c:pt idx="1">
                  <c:v>1.0768141810795839</c:v>
                </c:pt>
                <c:pt idx="2">
                  <c:v>1.214501138671755</c:v>
                </c:pt>
                <c:pt idx="3">
                  <c:v>2.1302394288176281</c:v>
                </c:pt>
                <c:pt idx="4">
                  <c:v>1.7209946451652609</c:v>
                </c:pt>
                <c:pt idx="5">
                  <c:v>1.0986028189819661</c:v>
                </c:pt>
                <c:pt idx="6">
                  <c:v>0.77928232904536199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'gum operon'!$A$18</c:f>
              <c:strCache>
                <c:ptCount val="1"/>
                <c:pt idx="0">
                  <c:v>gumL (Xoo3169)</c:v>
                </c:pt>
              </c:strCache>
            </c:strRef>
          </c:tx>
          <c:spPr>
            <a:ln w="12700">
              <a:solidFill>
                <a:prstClr val="black"/>
              </a:solidFill>
              <a:prstDash val="sysDot"/>
            </a:ln>
          </c:spPr>
          <c:marker>
            <c:symbol val="square"/>
            <c:size val="5"/>
            <c:spPr>
              <a:noFill/>
              <a:ln>
                <a:solidFill>
                  <a:prstClr val="black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18:$H$18</c:f>
              <c:numCache>
                <c:formatCode>General</c:formatCode>
                <c:ptCount val="7"/>
                <c:pt idx="0">
                  <c:v>1</c:v>
                </c:pt>
                <c:pt idx="1">
                  <c:v>0.98859695710581397</c:v>
                </c:pt>
                <c:pt idx="2">
                  <c:v>1.212127839045269</c:v>
                </c:pt>
                <c:pt idx="3">
                  <c:v>2.199162735480646</c:v>
                </c:pt>
                <c:pt idx="4">
                  <c:v>1.7864350651379299</c:v>
                </c:pt>
                <c:pt idx="5">
                  <c:v>0.89924708675684994</c:v>
                </c:pt>
                <c:pt idx="6">
                  <c:v>0.73947952138461104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'gum operon'!$A$19</c:f>
              <c:strCache>
                <c:ptCount val="1"/>
                <c:pt idx="0">
                  <c:v>gumK (Xoo3170)</c:v>
                </c:pt>
              </c:strCache>
            </c:strRef>
          </c:tx>
          <c:spPr>
            <a:ln w="12700">
              <a:solidFill>
                <a:prstClr val="black"/>
              </a:solidFill>
              <a:prstDash val="sysDash"/>
            </a:ln>
          </c:spPr>
          <c:marker>
            <c:symbol val="circl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19:$H$19</c:f>
              <c:numCache>
                <c:formatCode>General</c:formatCode>
                <c:ptCount val="7"/>
                <c:pt idx="0">
                  <c:v>1</c:v>
                </c:pt>
                <c:pt idx="1">
                  <c:v>1.005708228002935</c:v>
                </c:pt>
                <c:pt idx="2">
                  <c:v>1.3453885672347721</c:v>
                </c:pt>
                <c:pt idx="3">
                  <c:v>1.845959390035065</c:v>
                </c:pt>
                <c:pt idx="4">
                  <c:v>1.43105276033597</c:v>
                </c:pt>
                <c:pt idx="5">
                  <c:v>0.92677158933376802</c:v>
                </c:pt>
                <c:pt idx="6">
                  <c:v>0.77167087988257399</c:v>
                </c:pt>
              </c:numCache>
            </c:numRef>
          </c:val>
          <c:smooth val="1"/>
        </c:ser>
        <c:ser>
          <c:idx val="3"/>
          <c:order val="3"/>
          <c:tx>
            <c:strRef>
              <c:f>'gum operon'!$A$20</c:f>
              <c:strCache>
                <c:ptCount val="1"/>
                <c:pt idx="0">
                  <c:v>gumJ (Xoo3171)</c:v>
                </c:pt>
              </c:strCache>
            </c:strRef>
          </c:tx>
          <c:spPr>
            <a:ln w="12700">
              <a:solidFill>
                <a:prstClr val="black"/>
              </a:solidFill>
              <a:prstDash val="dash"/>
            </a:ln>
          </c:spPr>
          <c:marker>
            <c:symbol val="circle"/>
            <c:size val="5"/>
            <c:spPr>
              <a:noFill/>
              <a:ln>
                <a:solidFill>
                  <a:prstClr val="black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20:$H$20</c:f>
              <c:numCache>
                <c:formatCode>General</c:formatCode>
                <c:ptCount val="7"/>
                <c:pt idx="0">
                  <c:v>1</c:v>
                </c:pt>
                <c:pt idx="1">
                  <c:v>1.295266468056935</c:v>
                </c:pt>
                <c:pt idx="2">
                  <c:v>1.7803155687962049</c:v>
                </c:pt>
                <c:pt idx="3">
                  <c:v>2.7389385413218581</c:v>
                </c:pt>
                <c:pt idx="4">
                  <c:v>1.8903232925079989</c:v>
                </c:pt>
                <c:pt idx="5">
                  <c:v>1.4257971973960051</c:v>
                </c:pt>
                <c:pt idx="6">
                  <c:v>1.133620214057155</c:v>
                </c:pt>
              </c:numCache>
            </c:numRef>
          </c:val>
          <c:smooth val="1"/>
        </c:ser>
        <c:ser>
          <c:idx val="4"/>
          <c:order val="4"/>
          <c:tx>
            <c:strRef>
              <c:f>'gum operon'!$A$21</c:f>
              <c:strCache>
                <c:ptCount val="1"/>
                <c:pt idx="0">
                  <c:v>gumI (Xoo3172)</c:v>
                </c:pt>
              </c:strCache>
            </c:strRef>
          </c:tx>
          <c:spPr>
            <a:ln w="12700">
              <a:solidFill>
                <a:prstClr val="black"/>
              </a:solidFill>
              <a:prstDash val="dashDot"/>
            </a:ln>
          </c:spPr>
          <c:marker>
            <c:symbol val="diamond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21:$H$21</c:f>
              <c:numCache>
                <c:formatCode>General</c:formatCode>
                <c:ptCount val="7"/>
                <c:pt idx="0">
                  <c:v>1</c:v>
                </c:pt>
                <c:pt idx="1">
                  <c:v>1.2733552259087311</c:v>
                </c:pt>
                <c:pt idx="2">
                  <c:v>2.5922319103159328</c:v>
                </c:pt>
                <c:pt idx="3">
                  <c:v>3.3762880760955731</c:v>
                </c:pt>
                <c:pt idx="4">
                  <c:v>2.1649869776922208</c:v>
                </c:pt>
                <c:pt idx="5">
                  <c:v>1.5831729135998189</c:v>
                </c:pt>
                <c:pt idx="6">
                  <c:v>1.238138376174839</c:v>
                </c:pt>
              </c:numCache>
            </c:numRef>
          </c:val>
          <c:smooth val="1"/>
        </c:ser>
        <c:ser>
          <c:idx val="5"/>
          <c:order val="5"/>
          <c:tx>
            <c:strRef>
              <c:f>'gum operon'!$A$22</c:f>
              <c:strCache>
                <c:ptCount val="1"/>
                <c:pt idx="0">
                  <c:v>gumH (Xoo3173)</c:v>
                </c:pt>
              </c:strCache>
            </c:strRef>
          </c:tx>
          <c:spPr>
            <a:ln w="12700">
              <a:solidFill>
                <a:prstClr val="black"/>
              </a:solidFill>
              <a:prstDash val="lgDash"/>
            </a:ln>
          </c:spPr>
          <c:marker>
            <c:symbol val="diamond"/>
            <c:size val="5"/>
            <c:spPr>
              <a:noFill/>
              <a:ln>
                <a:solidFill>
                  <a:prstClr val="black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22:$H$22</c:f>
              <c:numCache>
                <c:formatCode>General</c:formatCode>
                <c:ptCount val="7"/>
                <c:pt idx="0">
                  <c:v>1</c:v>
                </c:pt>
                <c:pt idx="1">
                  <c:v>1.579828690485376</c:v>
                </c:pt>
                <c:pt idx="2">
                  <c:v>3.0589551662936949</c:v>
                </c:pt>
                <c:pt idx="3">
                  <c:v>3.62589705995833</c:v>
                </c:pt>
                <c:pt idx="4">
                  <c:v>2.0714561308742949</c:v>
                </c:pt>
                <c:pt idx="5">
                  <c:v>1.4792808087043749</c:v>
                </c:pt>
                <c:pt idx="6">
                  <c:v>1.1000848830928309</c:v>
                </c:pt>
              </c:numCache>
            </c:numRef>
          </c:val>
          <c:smooth val="1"/>
        </c:ser>
        <c:ser>
          <c:idx val="6"/>
          <c:order val="6"/>
          <c:tx>
            <c:strRef>
              <c:f>'gum operon'!$A$67</c:f>
              <c:strCache>
                <c:ptCount val="1"/>
                <c:pt idx="0">
                  <c:v>gumM (Xoo3168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7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67:$H$67</c:f>
              <c:numCache>
                <c:formatCode>General</c:formatCode>
                <c:ptCount val="7"/>
                <c:pt idx="0">
                  <c:v>1</c:v>
                </c:pt>
                <c:pt idx="1">
                  <c:v>1.087098162148872</c:v>
                </c:pt>
                <c:pt idx="2">
                  <c:v>1.174073391111931</c:v>
                </c:pt>
                <c:pt idx="3">
                  <c:v>1.165158882732104</c:v>
                </c:pt>
                <c:pt idx="4">
                  <c:v>1.0606675271989681</c:v>
                </c:pt>
                <c:pt idx="5">
                  <c:v>0.92679328784805504</c:v>
                </c:pt>
                <c:pt idx="6">
                  <c:v>0.89009773188272201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gum operon'!$A$68</c:f>
              <c:strCache>
                <c:ptCount val="1"/>
                <c:pt idx="0">
                  <c:v>gumL (Xoo3169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ysDot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68:$H$68</c:f>
              <c:numCache>
                <c:formatCode>General</c:formatCode>
                <c:ptCount val="7"/>
                <c:pt idx="0">
                  <c:v>1</c:v>
                </c:pt>
                <c:pt idx="1">
                  <c:v>1.1843772218990369</c:v>
                </c:pt>
                <c:pt idx="2">
                  <c:v>1.1627561243617099</c:v>
                </c:pt>
                <c:pt idx="3">
                  <c:v>1.1288236417714961</c:v>
                </c:pt>
                <c:pt idx="4">
                  <c:v>0.99049835175489598</c:v>
                </c:pt>
                <c:pt idx="5">
                  <c:v>0.96632409023333998</c:v>
                </c:pt>
                <c:pt idx="6">
                  <c:v>0.9404046280137029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gum operon'!$A$69</c:f>
              <c:strCache>
                <c:ptCount val="1"/>
                <c:pt idx="0">
                  <c:v>gumK (Xoo3170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ysDash"/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69:$H$69</c:f>
              <c:numCache>
                <c:formatCode>General</c:formatCode>
                <c:ptCount val="7"/>
                <c:pt idx="0">
                  <c:v>1</c:v>
                </c:pt>
                <c:pt idx="1">
                  <c:v>1.1776464083698379</c:v>
                </c:pt>
                <c:pt idx="2">
                  <c:v>1.1611448985667501</c:v>
                </c:pt>
                <c:pt idx="3">
                  <c:v>0.99284940411700995</c:v>
                </c:pt>
                <c:pt idx="4">
                  <c:v>0.99013311784970004</c:v>
                </c:pt>
                <c:pt idx="5">
                  <c:v>0.91081529366733305</c:v>
                </c:pt>
                <c:pt idx="6">
                  <c:v>0.96406243354739896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gum operon'!$A$70</c:f>
              <c:strCache>
                <c:ptCount val="1"/>
                <c:pt idx="0">
                  <c:v>gumJ (Xoo3171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circl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70:$H$70</c:f>
              <c:numCache>
                <c:formatCode>General</c:formatCode>
                <c:ptCount val="7"/>
                <c:pt idx="0">
                  <c:v>1</c:v>
                </c:pt>
                <c:pt idx="1">
                  <c:v>0.86864969845650597</c:v>
                </c:pt>
                <c:pt idx="2">
                  <c:v>0.94868649698456498</c:v>
                </c:pt>
                <c:pt idx="3">
                  <c:v>1.270887267592375</c:v>
                </c:pt>
                <c:pt idx="4">
                  <c:v>1.2010630685883681</c:v>
                </c:pt>
                <c:pt idx="5">
                  <c:v>0.92118981907390396</c:v>
                </c:pt>
                <c:pt idx="6">
                  <c:v>0.71430031687621398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gum operon'!$A$71</c:f>
              <c:strCache>
                <c:ptCount val="1"/>
                <c:pt idx="0">
                  <c:v>gumI (Xoo3172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Dot"/>
            </a:ln>
          </c:spPr>
          <c:marker>
            <c:symbol val="diamond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71:$H$71</c:f>
              <c:numCache>
                <c:formatCode>General</c:formatCode>
                <c:ptCount val="7"/>
                <c:pt idx="0">
                  <c:v>1</c:v>
                </c:pt>
                <c:pt idx="1">
                  <c:v>0.87550828902095701</c:v>
                </c:pt>
                <c:pt idx="2">
                  <c:v>0.91283494943175902</c:v>
                </c:pt>
                <c:pt idx="3">
                  <c:v>1.2194831487436</c:v>
                </c:pt>
                <c:pt idx="4">
                  <c:v>0.96423730580752798</c:v>
                </c:pt>
                <c:pt idx="5">
                  <c:v>0.91929934313418904</c:v>
                </c:pt>
                <c:pt idx="6">
                  <c:v>0.79042852674382202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'gum operon'!$A$72</c:f>
              <c:strCache>
                <c:ptCount val="1"/>
                <c:pt idx="0">
                  <c:v>gumH (Xoo3173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diamond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'gum operon'!$B$15:$H$1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'gum operon'!$B$72:$H$72</c:f>
              <c:numCache>
                <c:formatCode>General</c:formatCode>
                <c:ptCount val="7"/>
                <c:pt idx="0">
                  <c:v>1</c:v>
                </c:pt>
                <c:pt idx="1">
                  <c:v>0.99069489499743901</c:v>
                </c:pt>
                <c:pt idx="2">
                  <c:v>0.99334130100734097</c:v>
                </c:pt>
                <c:pt idx="3">
                  <c:v>1.092804825506247</c:v>
                </c:pt>
                <c:pt idx="4">
                  <c:v>1.0084514256445281</c:v>
                </c:pt>
                <c:pt idx="5">
                  <c:v>0.86460645381594703</c:v>
                </c:pt>
                <c:pt idx="6">
                  <c:v>0.8252518354106199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3941760"/>
        <c:axId val="73943680"/>
      </c:lineChart>
      <c:catAx>
        <c:axId val="73941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73943680"/>
        <c:crosses val="autoZero"/>
        <c:auto val="1"/>
        <c:lblAlgn val="ctr"/>
        <c:lblOffset val="100"/>
        <c:noMultiLvlLbl val="0"/>
      </c:catAx>
      <c:valAx>
        <c:axId val="73943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73941760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59930443426937197"/>
          <c:y val="0.23154588898686099"/>
          <c:w val="0.25256848952231797"/>
          <c:h val="0.76508353113933403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167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60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813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6197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5847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4649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3165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73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135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341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360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2626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115617" y="1076121"/>
            <a:ext cx="6814881" cy="3556211"/>
            <a:chOff x="790346" y="2132856"/>
            <a:chExt cx="5941894" cy="2794608"/>
          </a:xfrm>
        </p:grpSpPr>
        <p:graphicFrame>
          <p:nvGraphicFramePr>
            <p:cNvPr id="3" name="차트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01762539"/>
                </p:ext>
              </p:extLst>
            </p:nvPr>
          </p:nvGraphicFramePr>
          <p:xfrm>
            <a:off x="971600" y="2132856"/>
            <a:ext cx="576064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 rot="16200000">
              <a:off x="513761" y="3529030"/>
              <a:ext cx="781267" cy="2280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623130" y="4721881"/>
              <a:ext cx="434952" cy="205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2684" y="82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S6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775820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1</TotalTime>
  <Words>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dausr</dc:creator>
  <cp:lastModifiedBy>Banua, Arvin</cp:lastModifiedBy>
  <cp:revision>28</cp:revision>
  <dcterms:created xsi:type="dcterms:W3CDTF">2016-01-26T07:31:38Z</dcterms:created>
  <dcterms:modified xsi:type="dcterms:W3CDTF">2016-04-28T09:53:02Z</dcterms:modified>
</cp:coreProperties>
</file>